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8" r:id="rId2"/>
  </p:sldIdLst>
  <p:sldSz cx="9906000" cy="6858000" type="A4"/>
  <p:notesSz cx="6797675" cy="9926638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312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46AAC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4781" autoAdjust="0"/>
    <p:restoredTop sz="96374" autoAdjust="0"/>
  </p:normalViewPr>
  <p:slideViewPr>
    <p:cSldViewPr snapToGrid="0">
      <p:cViewPr>
        <p:scale>
          <a:sx n="100" d="100"/>
          <a:sy n="100" d="100"/>
        </p:scale>
        <p:origin x="-2022" y="-312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A635410-8A9E-4734-8363-1AF794AC7376}" type="datetimeFigureOut">
              <a:rPr lang="de-DE" smtClean="0"/>
              <a:t>03.02.2021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711200" y="744538"/>
            <a:ext cx="537527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79450" y="4714875"/>
            <a:ext cx="5438775" cy="44672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49688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05BFF1E-2D30-4CB2-9A28-76A729EF608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3712584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742950" y="2130426"/>
            <a:ext cx="8420100" cy="1470025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485900" y="3886200"/>
            <a:ext cx="69342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936CB3-2776-4D47-865A-C5E605127B0A}" type="datetimeFigureOut">
              <a:rPr lang="en-GB" smtClean="0"/>
              <a:t>03/02/2021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DEF780-AA30-42AA-AB20-A0908412613B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473229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936CB3-2776-4D47-865A-C5E605127B0A}" type="datetimeFigureOut">
              <a:rPr lang="en-GB" smtClean="0"/>
              <a:t>03/02/2021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DEF780-AA30-42AA-AB20-A0908412613B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804749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7181850" y="274639"/>
            <a:ext cx="2228850" cy="5851525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95300" y="274639"/>
            <a:ext cx="6521450" cy="5851525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936CB3-2776-4D47-865A-C5E605127B0A}" type="datetimeFigureOut">
              <a:rPr lang="en-GB" smtClean="0"/>
              <a:t>03/02/2021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DEF780-AA30-42AA-AB20-A0908412613B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656852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936CB3-2776-4D47-865A-C5E605127B0A}" type="datetimeFigureOut">
              <a:rPr lang="en-GB" smtClean="0"/>
              <a:t>03/02/2021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DEF780-AA30-42AA-AB20-A0908412613B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189964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82506" y="4406901"/>
            <a:ext cx="84201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82506" y="2906713"/>
            <a:ext cx="84201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936CB3-2776-4D47-865A-C5E605127B0A}" type="datetimeFigureOut">
              <a:rPr lang="en-GB" smtClean="0"/>
              <a:t>03/02/2021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DEF780-AA30-42AA-AB20-A0908412613B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656564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95300" y="1600201"/>
            <a:ext cx="437515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5035550" y="1600201"/>
            <a:ext cx="437515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936CB3-2776-4D47-865A-C5E605127B0A}" type="datetimeFigureOut">
              <a:rPr lang="en-GB" smtClean="0"/>
              <a:t>03/02/2021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DEF780-AA30-42AA-AB20-A0908412613B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188956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95300" y="1535113"/>
            <a:ext cx="437687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95300" y="2174875"/>
            <a:ext cx="437687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5032111" y="1535113"/>
            <a:ext cx="437859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5032111" y="2174875"/>
            <a:ext cx="437859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936CB3-2776-4D47-865A-C5E605127B0A}" type="datetimeFigureOut">
              <a:rPr lang="en-GB" smtClean="0"/>
              <a:t>03/02/2021</a:t>
            </a:fld>
            <a:endParaRPr lang="en-GB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DEF780-AA30-42AA-AB20-A0908412613B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091627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936CB3-2776-4D47-865A-C5E605127B0A}" type="datetimeFigureOut">
              <a:rPr lang="en-GB" smtClean="0"/>
              <a:t>03/02/2021</a:t>
            </a:fld>
            <a:endParaRPr lang="en-GB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DEF780-AA30-42AA-AB20-A0908412613B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815719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936CB3-2776-4D47-865A-C5E605127B0A}" type="datetimeFigureOut">
              <a:rPr lang="en-GB" smtClean="0"/>
              <a:t>03/02/2021</a:t>
            </a:fld>
            <a:endParaRPr lang="en-GB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DEF780-AA30-42AA-AB20-A0908412613B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324319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95300" y="273050"/>
            <a:ext cx="3259006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872971" y="273051"/>
            <a:ext cx="5537729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95300" y="1435101"/>
            <a:ext cx="3259006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936CB3-2776-4D47-865A-C5E605127B0A}" type="datetimeFigureOut">
              <a:rPr lang="en-GB" smtClean="0"/>
              <a:t>03/02/2021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DEF780-AA30-42AA-AB20-A0908412613B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622423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941645" y="4800600"/>
            <a:ext cx="59436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941645" y="612775"/>
            <a:ext cx="59436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941645" y="5367338"/>
            <a:ext cx="59436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936CB3-2776-4D47-865A-C5E605127B0A}" type="datetimeFigureOut">
              <a:rPr lang="en-GB" smtClean="0"/>
              <a:t>03/02/2021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DEF780-AA30-42AA-AB20-A0908412613B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157122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95300" y="1600201"/>
            <a:ext cx="89154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95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936CB3-2776-4D47-865A-C5E605127B0A}" type="datetimeFigureOut">
              <a:rPr lang="en-GB" smtClean="0"/>
              <a:t>03/02/2021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384550" y="6356351"/>
            <a:ext cx="31369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7099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DEF780-AA30-42AA-AB20-A0908412613B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451991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85066" y="40368"/>
            <a:ext cx="7327816" cy="6150882"/>
          </a:xfrm>
          <a:prstGeom prst="rect">
            <a:avLst/>
          </a:prstGeom>
        </p:spPr>
      </p:pic>
      <p:sp>
        <p:nvSpPr>
          <p:cNvPr id="4" name="Rechteck 3"/>
          <p:cNvSpPr/>
          <p:nvPr/>
        </p:nvSpPr>
        <p:spPr>
          <a:xfrm>
            <a:off x="1133475" y="6203514"/>
            <a:ext cx="7400926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/>
              <a:t>Figure </a:t>
            </a:r>
            <a:r>
              <a:rPr lang="en-US" sz="1200" b="1" dirty="0" smtClean="0"/>
              <a:t>S1</a:t>
            </a:r>
            <a:r>
              <a:rPr lang="en-US" sz="1200" b="1" dirty="0"/>
              <a:t>. </a:t>
            </a:r>
            <a:r>
              <a:rPr lang="en-US" sz="1200" dirty="0" smtClean="0"/>
              <a:t>Scanning </a:t>
            </a:r>
            <a:r>
              <a:rPr lang="en-US" sz="1200" dirty="0"/>
              <a:t>electron microscopy of three non-axenic cyanobacteria, i.e. </a:t>
            </a:r>
            <a:r>
              <a:rPr lang="en-US" sz="1200" i="1" dirty="0" err="1"/>
              <a:t>Stigonema</a:t>
            </a:r>
            <a:r>
              <a:rPr lang="en-US" sz="1200" i="1" dirty="0"/>
              <a:t> </a:t>
            </a:r>
            <a:r>
              <a:rPr lang="en-US" sz="1200" i="1" dirty="0" err="1"/>
              <a:t>ocellatum</a:t>
            </a:r>
            <a:r>
              <a:rPr lang="en-US" sz="1200" dirty="0"/>
              <a:t> DSM 106950 (</a:t>
            </a:r>
            <a:r>
              <a:rPr lang="en-US" sz="1200" dirty="0" smtClean="0"/>
              <a:t>A-C), </a:t>
            </a:r>
            <a:r>
              <a:rPr lang="en-US" sz="1200" i="1" dirty="0" err="1"/>
              <a:t>Chlorogloea</a:t>
            </a:r>
            <a:r>
              <a:rPr lang="en-US" sz="1200" i="1" dirty="0"/>
              <a:t> </a:t>
            </a:r>
            <a:r>
              <a:rPr lang="en-US" sz="1200" i="1" dirty="0" err="1"/>
              <a:t>purpurea</a:t>
            </a:r>
            <a:r>
              <a:rPr lang="en-US" sz="1200" dirty="0"/>
              <a:t> SAG 13.99 </a:t>
            </a:r>
            <a:r>
              <a:rPr lang="en-US" sz="1200" dirty="0" smtClean="0"/>
              <a:t>(D-F) </a:t>
            </a:r>
            <a:r>
              <a:rPr lang="en-US" sz="1200" dirty="0"/>
              <a:t>and </a:t>
            </a:r>
            <a:r>
              <a:rPr lang="en-US" sz="1200" i="1" dirty="0" err="1"/>
              <a:t>Gomphosphaeria</a:t>
            </a:r>
            <a:r>
              <a:rPr lang="en-US" sz="1200" i="1" dirty="0"/>
              <a:t> </a:t>
            </a:r>
            <a:r>
              <a:rPr lang="en-US" sz="1200" i="1" dirty="0" err="1"/>
              <a:t>aponina</a:t>
            </a:r>
            <a:r>
              <a:rPr lang="en-US" sz="1200" dirty="0"/>
              <a:t> DSM 107014 </a:t>
            </a:r>
            <a:r>
              <a:rPr lang="en-US" sz="1200" dirty="0" smtClean="0"/>
              <a:t>(G-I). Scale </a:t>
            </a:r>
            <a:r>
              <a:rPr lang="en-US" sz="1200" dirty="0"/>
              <a:t>bars </a:t>
            </a:r>
            <a:r>
              <a:rPr lang="en-US" sz="1200" dirty="0" smtClean="0"/>
              <a:t>in µm. Some coccoid, helical and rod-shaped bacteria are highlighted by arrows.</a:t>
            </a:r>
            <a:endParaRPr lang="de-DE" sz="1200" dirty="0"/>
          </a:p>
        </p:txBody>
      </p:sp>
    </p:spTree>
    <p:extLst>
      <p:ext uri="{BB962C8B-B14F-4D97-AF65-F5344CB8AC3E}">
        <p14:creationId xmlns:p14="http://schemas.microsoft.com/office/powerpoint/2010/main" val="300369532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2</Words>
  <Application>Microsoft Office PowerPoint</Application>
  <PresentationFormat>A4-Papier (210x297 mm)</PresentationFormat>
  <Paragraphs>1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Company>DSMZ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Pia Marter</dc:creator>
  <cp:lastModifiedBy>Petersen, Joern</cp:lastModifiedBy>
  <cp:revision>32</cp:revision>
  <cp:lastPrinted>2020-06-24T12:33:41Z</cp:lastPrinted>
  <dcterms:created xsi:type="dcterms:W3CDTF">2020-06-24T11:54:07Z</dcterms:created>
  <dcterms:modified xsi:type="dcterms:W3CDTF">2021-02-03T08:10:52Z</dcterms:modified>
</cp:coreProperties>
</file>